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64" d="100"/>
          <a:sy n="64" d="100"/>
        </p:scale>
        <p:origin x="490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FAB800-6361-4835-8BDF-F4A1C9420002}" type="datetimeFigureOut">
              <a:rPr lang="en-US" smtClean="0"/>
              <a:t>3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8A413F-6362-411D-B5FD-809D079CA6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51573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FAB800-6361-4835-8BDF-F4A1C9420002}" type="datetimeFigureOut">
              <a:rPr lang="en-US" smtClean="0"/>
              <a:t>3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8A413F-6362-411D-B5FD-809D079CA6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83411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FAB800-6361-4835-8BDF-F4A1C9420002}" type="datetimeFigureOut">
              <a:rPr lang="en-US" smtClean="0"/>
              <a:t>3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8A413F-6362-411D-B5FD-809D079CA6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05120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FAB800-6361-4835-8BDF-F4A1C9420002}" type="datetimeFigureOut">
              <a:rPr lang="en-US" smtClean="0"/>
              <a:t>3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8A413F-6362-411D-B5FD-809D079CA6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44264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FAB800-6361-4835-8BDF-F4A1C9420002}" type="datetimeFigureOut">
              <a:rPr lang="en-US" smtClean="0"/>
              <a:t>3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8A413F-6362-411D-B5FD-809D079CA6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2878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FAB800-6361-4835-8BDF-F4A1C9420002}" type="datetimeFigureOut">
              <a:rPr lang="en-US" smtClean="0"/>
              <a:t>3/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8A413F-6362-411D-B5FD-809D079CA6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11432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FAB800-6361-4835-8BDF-F4A1C9420002}" type="datetimeFigureOut">
              <a:rPr lang="en-US" smtClean="0"/>
              <a:t>3/6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8A413F-6362-411D-B5FD-809D079CA6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03515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FAB800-6361-4835-8BDF-F4A1C9420002}" type="datetimeFigureOut">
              <a:rPr lang="en-US" smtClean="0"/>
              <a:t>3/6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8A413F-6362-411D-B5FD-809D079CA6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05849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FAB800-6361-4835-8BDF-F4A1C9420002}" type="datetimeFigureOut">
              <a:rPr lang="en-US" smtClean="0"/>
              <a:t>3/6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8A413F-6362-411D-B5FD-809D079CA6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44375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FAB800-6361-4835-8BDF-F4A1C9420002}" type="datetimeFigureOut">
              <a:rPr lang="en-US" smtClean="0"/>
              <a:t>3/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8A413F-6362-411D-B5FD-809D079CA6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85399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FAB800-6361-4835-8BDF-F4A1C9420002}" type="datetimeFigureOut">
              <a:rPr lang="en-US" smtClean="0"/>
              <a:t>3/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8A413F-6362-411D-B5FD-809D079CA6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96708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FAB800-6361-4835-8BDF-F4A1C9420002}" type="datetimeFigureOut">
              <a:rPr lang="en-US" smtClean="0"/>
              <a:t>3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8A413F-6362-411D-B5FD-809D079CA6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0157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552467" y="435081"/>
            <a:ext cx="9730219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l Figure 1. Correlation </a:t>
            </a:r>
            <a:r>
              <a:rPr lang="en-US" dirty="0" smtClean="0"/>
              <a:t>between CD47 expression and CD163+</a:t>
            </a:r>
            <a:r>
              <a:rPr lang="en-US" baseline="0" dirty="0" smtClean="0"/>
              <a:t> macrophage counts. 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2797257" y="5213732"/>
            <a:ext cx="687731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orrelation between </a:t>
            </a:r>
            <a:r>
              <a:rPr lang="en-US" dirty="0" smtClean="0"/>
              <a:t>CD163+ macrophage counts in PanNET and CD47 expression in tumor was analyzed with </a:t>
            </a:r>
            <a:r>
              <a:rPr lang="en-US" dirty="0"/>
              <a:t>P</a:t>
            </a:r>
            <a:r>
              <a:rPr lang="en-US" dirty="0" smtClean="0"/>
              <a:t>earson’s </a:t>
            </a:r>
            <a:r>
              <a:rPr lang="en-US" dirty="0" smtClean="0"/>
              <a:t>correlation assay. CD163+ counts negatively correlated with CD47 expression (r=-0.34).</a:t>
            </a:r>
            <a:endParaRPr lang="en-US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34179" y="805942"/>
            <a:ext cx="6840305" cy="44077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862879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8</TotalTime>
  <Words>47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angzhou</dc:creator>
  <cp:lastModifiedBy>wendy</cp:lastModifiedBy>
  <cp:revision>12</cp:revision>
  <dcterms:created xsi:type="dcterms:W3CDTF">2021-02-28T15:07:25Z</dcterms:created>
  <dcterms:modified xsi:type="dcterms:W3CDTF">2021-03-07T02:16:07Z</dcterms:modified>
</cp:coreProperties>
</file>